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9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63"/>
  </p:normalViewPr>
  <p:slideViewPr>
    <p:cSldViewPr snapToGrid="0" snapToObjects="1">
      <p:cViewPr varScale="1">
        <p:scale>
          <a:sx n="112" d="100"/>
          <a:sy n="112" d="100"/>
        </p:scale>
        <p:origin x="48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AA3E36-4A1A-174E-A5B9-8AB69AC4FB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678D23D-DC43-144C-B532-91330E1268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FD620B-681B-164E-9C56-A1C3DE4D21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337C7-0A76-4B4E-94EF-93B2E2D84BB7}" type="datetimeFigureOut">
              <a:rPr lang="en-US" smtClean="0"/>
              <a:t>7/2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258942-FDAA-2A41-B187-E93D25F59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59CC4B-2DCA-9447-9D2B-82E99BD25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B121A-B21A-4A47-8C71-554D63DF0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19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15AEE6-6C00-E84B-9893-BE2D866EF1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C5147B-CFA0-A64B-B92D-0DC813E362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A7FF82-50E1-0047-AB40-B4D9DBB4C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337C7-0A76-4B4E-94EF-93B2E2D84BB7}" type="datetimeFigureOut">
              <a:rPr lang="en-US" smtClean="0"/>
              <a:t>7/2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98ACAF-E726-5147-86B6-C06EF88AE6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29F03B-E3B6-304D-9C96-C26FD94C39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B121A-B21A-4A47-8C71-554D63DF0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26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B962FE0-11B7-3841-A337-AA39A0A390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48EF5E-A751-9343-BADE-9E5E854513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D5F509-0E62-0241-B1CB-39AB95EF7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337C7-0A76-4B4E-94EF-93B2E2D84BB7}" type="datetimeFigureOut">
              <a:rPr lang="en-US" smtClean="0"/>
              <a:t>7/2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3694C1-6C48-5342-BC34-AEE6D34F37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C402F6-406B-EB4F-BC96-DC863394A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B121A-B21A-4A47-8C71-554D63DF0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901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E174AC-A081-A84A-A761-13CC188F96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B0C1DD-77F2-5840-9B09-28E096C985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2E3979-1529-C04C-91BB-090D1BDAE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337C7-0A76-4B4E-94EF-93B2E2D84BB7}" type="datetimeFigureOut">
              <a:rPr lang="en-US" smtClean="0"/>
              <a:t>7/2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C02836-C1EC-3743-900B-41B6E0A09D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5FA983-7527-0342-AAEC-A479881020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B121A-B21A-4A47-8C71-554D63DF0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54674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3CDE88-587D-F44A-B98A-160361D2EE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A7A24A-05D2-BF4D-982A-47FB584C65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2CE512-77BB-6D4B-9185-D176F3198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337C7-0A76-4B4E-94EF-93B2E2D84BB7}" type="datetimeFigureOut">
              <a:rPr lang="en-US" smtClean="0"/>
              <a:t>7/2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BEC66D-38F5-F74A-999A-A5361A46B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97D1CC-7435-1D4B-8760-3500A9E5AA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B121A-B21A-4A47-8C71-554D63DF0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229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715F8A-64B7-BF44-9F41-782AC39694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09ECF1-E4A9-3B4E-A077-EEC4455DAF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9A1637-4ADF-B748-A6FE-AA483030BA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525C36-8337-A04E-B146-C0EFA129C7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337C7-0A76-4B4E-94EF-93B2E2D84BB7}" type="datetimeFigureOut">
              <a:rPr lang="en-US" smtClean="0"/>
              <a:t>7/2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483287-AF06-BF47-99FD-64DEBDD57F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A2950B-88C9-6D4A-B0E4-F216FEA208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B121A-B21A-4A47-8C71-554D63DF0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776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A5BD51-2D8C-8B4A-AD59-ABD1F39FF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7D7213-0113-D64D-8AC7-F58174518E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36C2B4-0574-3249-ACA1-E212014782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CF58097-AD5D-3546-9E8F-F365E3D131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C6E2A9C-127D-C540-8D0B-7F9F3D3155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123700-FADD-7E48-A90A-D9494209F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337C7-0A76-4B4E-94EF-93B2E2D84BB7}" type="datetimeFigureOut">
              <a:rPr lang="en-US" smtClean="0"/>
              <a:t>7/27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4F5FA94-540B-904B-8E3F-3FB452072C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3525F94-8569-2340-A5B4-491C6BE2E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B121A-B21A-4A47-8C71-554D63DF0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649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40142D-A040-D443-97B2-FBBBFBEF13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08247B-14DE-0942-B507-CDB80C203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337C7-0A76-4B4E-94EF-93B2E2D84BB7}" type="datetimeFigureOut">
              <a:rPr lang="en-US" smtClean="0"/>
              <a:t>7/27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AC8493-F828-B644-AD26-5D2EF5673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1EF6AA8-0273-8147-907B-2C442C794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B121A-B21A-4A47-8C71-554D63DF0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7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54DDB80-B77A-5642-9532-1D19ACA28D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337C7-0A76-4B4E-94EF-93B2E2D84BB7}" type="datetimeFigureOut">
              <a:rPr lang="en-US" smtClean="0"/>
              <a:t>7/27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E918D28-81C5-8040-B791-D8094C357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1FDFF3C-2FF7-4B41-A37E-740C9ED83F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B121A-B21A-4A47-8C71-554D63DF0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36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732308-AF94-5A4B-B156-644BD81865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412A97-70F5-164D-A7EF-5BDA544D5F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214C29-DD93-A248-B173-CCAA6D492D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CDC829-692D-EA42-845F-34C7E9BBC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337C7-0A76-4B4E-94EF-93B2E2D84BB7}" type="datetimeFigureOut">
              <a:rPr lang="en-US" smtClean="0"/>
              <a:t>7/2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DC2B04-D27A-A945-9D81-9BE97BCF27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F2D842-AE89-FD4E-A9C0-DAB8AEA94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B121A-B21A-4A47-8C71-554D63DF0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980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FB983C-461D-2847-8738-FB051C2BB2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69B68CB-A35D-B145-88E8-E89BAA110AB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2215ED7-1AAD-B343-88B2-36059B61BB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F6232B-A075-FA4A-A0B3-191403E7A8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337C7-0A76-4B4E-94EF-93B2E2D84BB7}" type="datetimeFigureOut">
              <a:rPr lang="en-US" smtClean="0"/>
              <a:t>7/2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ECFAC0-1F1F-7C45-AD49-4FC4B6B2B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B88BC3-B23D-194F-92AE-830DF5084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B121A-B21A-4A47-8C71-554D63DF0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5875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4F7879D-E137-9848-9650-E76D87E514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D3952D-582D-6846-914A-895A2F4A84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FD7F01-CA97-FB4E-A1BA-DCE3B1EC91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5337C7-0A76-4B4E-94EF-93B2E2D84BB7}" type="datetimeFigureOut">
              <a:rPr lang="en-US" smtClean="0"/>
              <a:t>7/2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EE9339-B6A5-544A-A503-5A82E9B5D6B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D896B3-1D31-164A-A5F0-486445111B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5B121A-B21A-4A47-8C71-554D63DF0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989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9E39F6-2CF7-7146-976F-6EB43EA2B1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5394960"/>
            <a:ext cx="10515600" cy="782002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600" b="1" dirty="0"/>
              <a:t>Figure 6.</a:t>
            </a:r>
            <a:r>
              <a:rPr lang="en-US" sz="1600" dirty="0"/>
              <a:t>  Coronary artery disease area under receiver operating characteristic curve and precision-recall curve for both multivariate logistic regression and random forest models. Each curve represents a different model input combination. Vital signs data extraction window was held constant at 360 minutes for all inputs.  </a:t>
            </a:r>
          </a:p>
          <a:p>
            <a:pPr marL="0" indent="0">
              <a:buNone/>
            </a:pPr>
            <a:endParaRPr lang="en-US" dirty="0"/>
          </a:p>
        </p:txBody>
      </p:sp>
      <p:sp>
        <p:nvSpPr>
          <p:cNvPr id="6" name="Rectangle 11">
            <a:extLst>
              <a:ext uri="{FF2B5EF4-FFF2-40B4-BE49-F238E27FC236}">
                <a16:creationId xmlns:a16="http://schemas.microsoft.com/office/drawing/2014/main" id="{1920E633-9318-6C41-87F7-355B5F6770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3210" y="9144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Rectangle 12">
            <a:extLst>
              <a:ext uri="{FF2B5EF4-FFF2-40B4-BE49-F238E27FC236}">
                <a16:creationId xmlns:a16="http://schemas.microsoft.com/office/drawing/2014/main" id="{4A0236D1-FC92-E840-AC5B-98407C834A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3210" y="927354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4" name="Picture 3" descr="A picture containing text, map&#10;&#10;Description automatically generated">
            <a:extLst>
              <a:ext uri="{FF2B5EF4-FFF2-40B4-BE49-F238E27FC236}">
                <a16:creationId xmlns:a16="http://schemas.microsoft.com/office/drawing/2014/main" id="{8F798F0C-84A3-FE40-B37A-496A65DAFF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3787" y="91440"/>
            <a:ext cx="6864425" cy="52561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58382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A4BDCD-1034-3046-ADDC-BBDCB6D276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5429249"/>
            <a:ext cx="10515600" cy="747713"/>
          </a:xfrm>
        </p:spPr>
        <p:txBody>
          <a:bodyPr>
            <a:normAutofit lnSpcReduction="10000"/>
          </a:bodyPr>
          <a:lstStyle/>
          <a:p>
            <a:pPr marL="0" indent="0">
              <a:buNone/>
            </a:pPr>
            <a:r>
              <a:rPr lang="en-US" sz="1600" b="1" dirty="0"/>
              <a:t>Figure 7.</a:t>
            </a:r>
            <a:r>
              <a:rPr lang="en-US" sz="1600" dirty="0"/>
              <a:t>  Hypertension area under receiver operating characteristic curve and precision-recall curve for both multivariate logistic regression and random forest models. Each curve represents a different model input combination. Vital signs data extraction window was held constant at 360 minutes for all inputs.  </a:t>
            </a:r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0E1D628B-BD04-9A4F-8429-CCF3CB03B2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A8757BCF-5E4E-4A41-9833-CE398A0BC6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92583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6" name="Picture 5" descr="A picture containing text, map&#10;&#10;Description automatically generated">
            <a:extLst>
              <a:ext uri="{FF2B5EF4-FFF2-40B4-BE49-F238E27FC236}">
                <a16:creationId xmlns:a16="http://schemas.microsoft.com/office/drawing/2014/main" id="{60BE0FC8-4A86-1845-B72B-651962DFCE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3868" y="91440"/>
            <a:ext cx="6864263" cy="52463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30315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399A84-C082-E140-957C-E1CC9896C9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5394960"/>
            <a:ext cx="10515600" cy="782002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600" b="1"/>
              <a:t>Figure 8.</a:t>
            </a:r>
            <a:r>
              <a:rPr lang="en-US" sz="1600"/>
              <a:t> </a:t>
            </a:r>
            <a:r>
              <a:rPr lang="en-US" sz="1600" dirty="0"/>
              <a:t>Myocardial infarction area under receiver operating characteristic curve and precision-recall curve for both multivariate logistic regression and random forest models. Each curve represents a different model input combination. Vital signs data extraction window was held constant at 360 minutes for all inputs.  </a:t>
            </a:r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430AE87C-C60B-8246-8ED7-396F1A06C4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8041BEF0-44CF-7F4E-9775-2B3CD56D82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92837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6" name="Picture 5" descr="A picture containing text, map&#10;&#10;Description automatically generated">
            <a:extLst>
              <a:ext uri="{FF2B5EF4-FFF2-40B4-BE49-F238E27FC236}">
                <a16:creationId xmlns:a16="http://schemas.microsoft.com/office/drawing/2014/main" id="{F08DC442-F8E5-F541-9061-560407FCE2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92843" y="95480"/>
            <a:ext cx="6806314" cy="52080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01116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44</Words>
  <Application>Microsoft Macintosh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say, Patrick Thomas - (pessay)</dc:creator>
  <cp:lastModifiedBy>Essay, Patrick Thomas - (pessay)</cp:lastModifiedBy>
  <cp:revision>6</cp:revision>
  <dcterms:created xsi:type="dcterms:W3CDTF">2020-05-05T18:39:57Z</dcterms:created>
  <dcterms:modified xsi:type="dcterms:W3CDTF">2020-07-27T18:12:35Z</dcterms:modified>
</cp:coreProperties>
</file>